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775"/>
  </p:normalViewPr>
  <p:slideViewPr>
    <p:cSldViewPr snapToGrid="0" snapToObjects="1">
      <p:cViewPr>
        <p:scale>
          <a:sx n="150" d="100"/>
          <a:sy n="150" d="100"/>
        </p:scale>
        <p:origin x="42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FE2C-23C1-824C-AE66-CABC44A9AAAB}" type="datetimeFigureOut">
              <a:rPr lang="en-US" smtClean="0"/>
              <a:t>12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CF4FF-5737-8F4E-93CD-AA14EAB2C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116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FE2C-23C1-824C-AE66-CABC44A9AAAB}" type="datetimeFigureOut">
              <a:rPr lang="en-US" smtClean="0"/>
              <a:t>12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CF4FF-5737-8F4E-93CD-AA14EAB2C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240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FE2C-23C1-824C-AE66-CABC44A9AAAB}" type="datetimeFigureOut">
              <a:rPr lang="en-US" smtClean="0"/>
              <a:t>12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CF4FF-5737-8F4E-93CD-AA14EAB2C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163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FE2C-23C1-824C-AE66-CABC44A9AAAB}" type="datetimeFigureOut">
              <a:rPr lang="en-US" smtClean="0"/>
              <a:t>12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CF4FF-5737-8F4E-93CD-AA14EAB2C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0113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FE2C-23C1-824C-AE66-CABC44A9AAAB}" type="datetimeFigureOut">
              <a:rPr lang="en-US" smtClean="0"/>
              <a:t>12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CF4FF-5737-8F4E-93CD-AA14EAB2C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55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FE2C-23C1-824C-AE66-CABC44A9AAAB}" type="datetimeFigureOut">
              <a:rPr lang="en-US" smtClean="0"/>
              <a:t>12/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CF4FF-5737-8F4E-93CD-AA14EAB2C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929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FE2C-23C1-824C-AE66-CABC44A9AAAB}" type="datetimeFigureOut">
              <a:rPr lang="en-US" smtClean="0"/>
              <a:t>12/6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CF4FF-5737-8F4E-93CD-AA14EAB2C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512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FE2C-23C1-824C-AE66-CABC44A9AAAB}" type="datetimeFigureOut">
              <a:rPr lang="en-US" smtClean="0"/>
              <a:t>12/6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CF4FF-5737-8F4E-93CD-AA14EAB2C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733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FE2C-23C1-824C-AE66-CABC44A9AAAB}" type="datetimeFigureOut">
              <a:rPr lang="en-US" smtClean="0"/>
              <a:t>12/6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CF4FF-5737-8F4E-93CD-AA14EAB2C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91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FE2C-23C1-824C-AE66-CABC44A9AAAB}" type="datetimeFigureOut">
              <a:rPr lang="en-US" smtClean="0"/>
              <a:t>12/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CF4FF-5737-8F4E-93CD-AA14EAB2C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9768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CFE2C-23C1-824C-AE66-CABC44A9AAAB}" type="datetimeFigureOut">
              <a:rPr lang="en-US" smtClean="0"/>
              <a:t>12/6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0CF4FF-5737-8F4E-93CD-AA14EAB2C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26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2CFE2C-23C1-824C-AE66-CABC44A9AAAB}" type="datetimeFigureOut">
              <a:rPr lang="en-US" smtClean="0"/>
              <a:t>12/6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0CF4FF-5737-8F4E-93CD-AA14EAB2CC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776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4252965-1311-ED46-B7A7-82B72584B9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6057027"/>
              </p:ext>
            </p:extLst>
          </p:nvPr>
        </p:nvGraphicFramePr>
        <p:xfrm>
          <a:off x="1050354" y="305337"/>
          <a:ext cx="7043291" cy="6518272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019400">
                  <a:extLst>
                    <a:ext uri="{9D8B030D-6E8A-4147-A177-3AD203B41FA5}">
                      <a16:colId xmlns:a16="http://schemas.microsoft.com/office/drawing/2014/main" val="1151963073"/>
                    </a:ext>
                  </a:extLst>
                </a:gridCol>
                <a:gridCol w="490493">
                  <a:extLst>
                    <a:ext uri="{9D8B030D-6E8A-4147-A177-3AD203B41FA5}">
                      <a16:colId xmlns:a16="http://schemas.microsoft.com/office/drawing/2014/main" val="2660521640"/>
                    </a:ext>
                  </a:extLst>
                </a:gridCol>
                <a:gridCol w="88557">
                  <a:extLst>
                    <a:ext uri="{9D8B030D-6E8A-4147-A177-3AD203B41FA5}">
                      <a16:colId xmlns:a16="http://schemas.microsoft.com/office/drawing/2014/main" val="1239761530"/>
                    </a:ext>
                  </a:extLst>
                </a:gridCol>
                <a:gridCol w="370087">
                  <a:extLst>
                    <a:ext uri="{9D8B030D-6E8A-4147-A177-3AD203B41FA5}">
                      <a16:colId xmlns:a16="http://schemas.microsoft.com/office/drawing/2014/main" val="2316504083"/>
                    </a:ext>
                  </a:extLst>
                </a:gridCol>
                <a:gridCol w="490493">
                  <a:extLst>
                    <a:ext uri="{9D8B030D-6E8A-4147-A177-3AD203B41FA5}">
                      <a16:colId xmlns:a16="http://schemas.microsoft.com/office/drawing/2014/main" val="1571805172"/>
                    </a:ext>
                  </a:extLst>
                </a:gridCol>
                <a:gridCol w="88557">
                  <a:extLst>
                    <a:ext uri="{9D8B030D-6E8A-4147-A177-3AD203B41FA5}">
                      <a16:colId xmlns:a16="http://schemas.microsoft.com/office/drawing/2014/main" val="1862947740"/>
                    </a:ext>
                  </a:extLst>
                </a:gridCol>
                <a:gridCol w="733156">
                  <a:extLst>
                    <a:ext uri="{9D8B030D-6E8A-4147-A177-3AD203B41FA5}">
                      <a16:colId xmlns:a16="http://schemas.microsoft.com/office/drawing/2014/main" val="477102708"/>
                    </a:ext>
                  </a:extLst>
                </a:gridCol>
                <a:gridCol w="733156">
                  <a:extLst>
                    <a:ext uri="{9D8B030D-6E8A-4147-A177-3AD203B41FA5}">
                      <a16:colId xmlns:a16="http://schemas.microsoft.com/office/drawing/2014/main" val="273368109"/>
                    </a:ext>
                  </a:extLst>
                </a:gridCol>
                <a:gridCol w="366393">
                  <a:extLst>
                    <a:ext uri="{9D8B030D-6E8A-4147-A177-3AD203B41FA5}">
                      <a16:colId xmlns:a16="http://schemas.microsoft.com/office/drawing/2014/main" val="3726173104"/>
                    </a:ext>
                  </a:extLst>
                </a:gridCol>
                <a:gridCol w="599082">
                  <a:extLst>
                    <a:ext uri="{9D8B030D-6E8A-4147-A177-3AD203B41FA5}">
                      <a16:colId xmlns:a16="http://schemas.microsoft.com/office/drawing/2014/main" val="2138575679"/>
                    </a:ext>
                  </a:extLst>
                </a:gridCol>
                <a:gridCol w="650422">
                  <a:extLst>
                    <a:ext uri="{9D8B030D-6E8A-4147-A177-3AD203B41FA5}">
                      <a16:colId xmlns:a16="http://schemas.microsoft.com/office/drawing/2014/main" val="441771500"/>
                    </a:ext>
                  </a:extLst>
                </a:gridCol>
                <a:gridCol w="396680">
                  <a:extLst>
                    <a:ext uri="{9D8B030D-6E8A-4147-A177-3AD203B41FA5}">
                      <a16:colId xmlns:a16="http://schemas.microsoft.com/office/drawing/2014/main" val="1318159683"/>
                    </a:ext>
                  </a:extLst>
                </a:gridCol>
                <a:gridCol w="650422">
                  <a:extLst>
                    <a:ext uri="{9D8B030D-6E8A-4147-A177-3AD203B41FA5}">
                      <a16:colId xmlns:a16="http://schemas.microsoft.com/office/drawing/2014/main" val="109370199"/>
                    </a:ext>
                  </a:extLst>
                </a:gridCol>
                <a:gridCol w="366393">
                  <a:extLst>
                    <a:ext uri="{9D8B030D-6E8A-4147-A177-3AD203B41FA5}">
                      <a16:colId xmlns:a16="http://schemas.microsoft.com/office/drawing/2014/main" val="3091854060"/>
                    </a:ext>
                  </a:extLst>
                </a:gridCol>
              </a:tblGrid>
              <a:tr h="127653">
                <a:tc>
                  <a:txBody>
                    <a:bodyPr/>
                    <a:lstStyle/>
                    <a:p>
                      <a:endParaRPr lang="en-GB" sz="4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400" dirty="0">
                          <a:effectLst/>
                        </a:rPr>
                        <a:t>Baseline</a:t>
                      </a:r>
                      <a:endParaRPr lang="en-GB" sz="5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lang="en-GB" sz="400" dirty="0">
                          <a:effectLst/>
                        </a:rPr>
                        <a:t>4 weeks</a:t>
                      </a:r>
                      <a:endParaRPr lang="en-GB" sz="5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lang="en-GB" sz="400" dirty="0">
                          <a:effectLst/>
                        </a:rPr>
                        <a:t>8 weeks</a:t>
                      </a:r>
                      <a:endParaRPr lang="en-GB" sz="5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2550086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endParaRPr lang="en-GB" sz="4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Mean (SD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Mean (SD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lang="en-GB" sz="40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GB" sz="400" dirty="0">
                          <a:effectLst/>
                        </a:rPr>
                        <a:t>Mean (SD)</a:t>
                      </a:r>
                      <a:endParaRPr lang="en-GB" sz="5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endParaRPr lang="en-GB" sz="4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43641418"/>
                  </a:ext>
                </a:extLst>
              </a:tr>
              <a:tr h="191479">
                <a:tc rowSpan="2">
                  <a:txBody>
                    <a:bodyPr/>
                    <a:lstStyle/>
                    <a:p>
                      <a:endParaRPr lang="en-GB" sz="40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28760" marR="2876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Interventio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Control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Interventio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Control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Adjusted mean difference 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p valu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Intervention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 dirty="0">
                          <a:effectLst/>
                        </a:rPr>
                        <a:t>Control</a:t>
                      </a:r>
                      <a:endParaRPr lang="en-GB" sz="5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Adjusted mean difference 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p valu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1885019160"/>
                  </a:ext>
                </a:extLst>
              </a:tr>
              <a:tr h="1276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(n 5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(n 5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(n 5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 (n 5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(95% CI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(n 5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 dirty="0">
                          <a:effectLst/>
                        </a:rPr>
                        <a:t>(n 56)</a:t>
                      </a:r>
                      <a:endParaRPr lang="en-GB" sz="5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(95% CI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12020694"/>
                  </a:ext>
                </a:extLst>
              </a:tr>
              <a:tr h="135631">
                <a:tc gridSpan="14">
                  <a:txBody>
                    <a:bodyPr/>
                    <a:lstStyle/>
                    <a:p>
                      <a:r>
                        <a:rPr lang="en-US" sz="400" dirty="0">
                          <a:effectLst/>
                        </a:rPr>
                        <a:t>Meat intake (g/d from disaggregated 7-days food diaries)</a:t>
                      </a:r>
                      <a:r>
                        <a:rPr lang="en-US" sz="400" baseline="30000" dirty="0">
                          <a:effectLst/>
                        </a:rPr>
                        <a:t>1</a:t>
                      </a:r>
                      <a:endParaRPr lang="en-GB" sz="5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33021641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Total processed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 dirty="0">
                          <a:effectLst/>
                        </a:rPr>
                        <a:t>52 (52)</a:t>
                      </a:r>
                      <a:endParaRPr lang="en-GB" sz="5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44 (3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2 (2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42 (3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24 (-32, -1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&lt;0.0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7 (3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 dirty="0">
                          <a:effectLst/>
                        </a:rPr>
                        <a:t>39 (29)</a:t>
                      </a:r>
                      <a:endParaRPr lang="en-GB" sz="5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16 (-25, -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009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3211268586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Total unprocessed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 dirty="0">
                          <a:effectLst/>
                        </a:rPr>
                        <a:t>77 (63)</a:t>
                      </a:r>
                      <a:endParaRPr lang="en-GB" sz="5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90 (5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30 (3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74 (5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42 (-57, -2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&lt;0.0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54 (5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82 (5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26 (-45, -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087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1909807015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Red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75 (6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78 (5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31 (3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65 (4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33 (-45, -2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&lt;0.0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42 (4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65 (5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22 (-37, -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042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2168327794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Red processed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44 (4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39 (3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0 (2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37 (3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20 (-28, -1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&lt;0.0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2 (2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36 (2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15 (-24, -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007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3327910669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Red unprocessed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31 (4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39 (4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1 (1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7 (2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15 (-23, -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002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1 (2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30 (3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8 (-18, 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129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1311978416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Red ruminant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28 (2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33 (2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6 (2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30 (2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13 (-22, -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017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8 (2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8 (2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9 (-18, 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587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161897589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Red ruminant processed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7 (1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8 (1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6 (1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8 (1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2 (-7, 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415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5 (1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6 (1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1 (-5, 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5139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1783366628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Red ruminant unprocessed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21 (2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25 (2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0 (1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2 (2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12 (-19, -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007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3 (1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1 (2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8 (-15, 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457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1767357623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Por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48 (5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45 (4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5 (2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35 (3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20 (-28, -1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&lt;0.0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4 (3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38 (3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14 (-25, -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1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4159283222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Pork processed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37 (4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31 (3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4 (2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9 (3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18 (-26, -1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&lt;0.0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7 (2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9 (2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15 (-23, -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00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784615093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Pork unprocessed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1 (2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4 (2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 (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5 (1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3 (-7, 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673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8 (1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8 (2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 (-7, 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9539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2823173913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Whit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53 (4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55 (4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0 (2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50 (3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29 (-41, -1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&lt;0.0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36 (4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54 (4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18 (-33, -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29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3976829480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White processed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8 (1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5 (1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 (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4 (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3 (-5, 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44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5 (1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3 (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 (-2, 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472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63535221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White unprocessed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45 (3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51 (3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8 (2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46 (3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26 (-38, -1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&lt;0.0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31 (4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51 (4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18 (-34, -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21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3179540437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Game meat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 (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 (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b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 (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 (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1 (-2, 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252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 (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 (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 (-2, 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6757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3092157005"/>
                  </a:ext>
                </a:extLst>
              </a:tr>
              <a:tr h="127653">
                <a:tc gridSpan="14"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Consumption frequency of food group (meals containing food groups per week on a possible scale from 0 to 4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90088577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Processed meat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5.3 (3.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4.6 (3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.2 (2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4.2 (3.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2.3 (-3.1, -1.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&lt;0.0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3.1 (3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4.5 (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1.7 (-2.6, -0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395193745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Unprocessed white/gam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3.3 (2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3.4 (1.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4 (1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3.1 (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1.7 (-2.3, -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&lt;0.0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.1 (2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3.2 (2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1.1 (-1.8, -0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08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1203592733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Unprocessed red ruminant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.3 (1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.5 (1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6 (0.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4 (1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7 (-1.1, -0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003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9 (1.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5 (1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5 (-0.9, 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539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1414265303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Unprocessed pork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0.5 (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0.8 (1.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1 (0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3 (0.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2 (-0.4, 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132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3 (0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5 (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1 (-0.5, 0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3802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4064034475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Mycoprotein substitutes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0.1 (0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0.1 (0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.7 (2.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 (0.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.7 (2.1, 3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&lt;0.0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5 (1.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1 (0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4 (0.9, 1.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&lt;0.0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3699276711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Soy and TVP substitutes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0.1 (0.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0.2 (0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.6 (2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2 (0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.4 (1.8, 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&lt;0.0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1 (1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2 (0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9 (0.6, 1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&lt;0.0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1593881619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Other substitutes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0.1 (0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0.1 (0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9 (1.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1 (0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8 (0.5, 1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&lt;0.00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4 (0.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1 (0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3 (0.1, 0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01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4122279371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Cheese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4.7 (2.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4.3 (2.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3.7 (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4.1 (2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5 (-1.5, 0.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261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4.7 (3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4 (2.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5 (-0.5, 1.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326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1147015532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Snacks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7.4 (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8.6 (5.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8.5 (4.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8.9 (5.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4 (-1.8, 0.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530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8.3 (5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8.4 (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 (-1.4, 1.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9753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4250353949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Fish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0 (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0 (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1.6 (1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.1 (1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3 (-0.9, 0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209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1.7 (2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.4 (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6 (-1.4, 0.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089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3878224670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Starchy foods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.1 (2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0.6 (1.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5.8 (4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5.8 (4.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3 (-1.5, 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6853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5.5 (3.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5 (4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2 (-0.9, 1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724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1533037639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Milk and yoghurt substitutes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.8 (1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2.1 (1.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7 (1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6 (1.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2 (-0.6, 0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3453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9 (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6 (1.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1 (-0.3, 0.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6158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3843463706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Milk and yoghurt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5.7 (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5.3 (4.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7.9 (6.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9 (5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1 (-1.4, 1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869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7.5 (5.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9.4 (6.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8 (-2.3, 0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258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261120708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Fruit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7.4 (5.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8.7 (5.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5.9 (4.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6.9 (4.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1 (-1.2, 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8182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5.6 (4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7.1 (6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5 (-1.8, 0.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5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232952079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Pulses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0.8 (3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1.6 (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 (2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.1 (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1 (-0.9, 0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767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.2 (2.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7 (1.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5 (-0.2, 1.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2036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3236561238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Eggs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2.1 (2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2 (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 dirty="0">
                          <a:effectLst/>
                        </a:rPr>
                        <a:t>1.9 (1.9)</a:t>
                      </a:r>
                      <a:endParaRPr lang="en-GB" sz="5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 (1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1 (-0.7, 0.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7658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2 (1.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9 (1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1 (-0.5, 0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8003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3743736786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Cheese substitutes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2 (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.9 (1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 (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 (0.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 (-0.1, 0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3089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1 (0.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 (0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 (-0.1, 0.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7883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2134322710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Nuts and seeds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.9 (3.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.8 (2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9 (2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7 (2.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1 (-0.6, 0.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775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9 (2.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8 (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1 (-0.8, 0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8183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2176247955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Soft drinks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9 (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9 (5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2 (2.5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2 (2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1 (-0.4, 0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7082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2 (2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9 (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4 (-0.2, 1.1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185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3499784188"/>
                  </a:ext>
                </a:extLst>
              </a:tr>
              <a:tr h="191479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Vegetables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.3 (2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1.3 (2.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0.6 (3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0.7 (2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3 (-0.7, 1.3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6004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0.9 (3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0.7 (3.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5 (-0.6, 1.7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3501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4162580689"/>
                  </a:ext>
                </a:extLst>
              </a:tr>
              <a:tr h="127653">
                <a:tc>
                  <a:txBody>
                    <a:bodyPr/>
                    <a:lstStyle/>
                    <a:p>
                      <a:r>
                        <a:rPr lang="en-US" sz="400">
                          <a:effectLst/>
                        </a:rPr>
                        <a:t>Alcoholic drinks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2 (2.4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r>
                        <a:rPr lang="en-GB" sz="400">
                          <a:effectLst/>
                        </a:rPr>
                        <a:t>2 (2.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.2 (2.8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9 (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0.3 (-0.4, 0.9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>
                          <a:effectLst/>
                        </a:rPr>
                        <a:t>0.3988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1.9 (2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2.2 (2.6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400">
                          <a:effectLst/>
                        </a:rPr>
                        <a:t>-0.4 (-1.1, 0.2)</a:t>
                      </a:r>
                      <a:endParaRPr lang="en-GB" sz="5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400" dirty="0">
                          <a:effectLst/>
                        </a:rPr>
                        <a:t>0.2199</a:t>
                      </a:r>
                      <a:endParaRPr lang="en-GB" sz="5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28760" marR="28760" marT="0" marB="0" anchor="ctr"/>
                </a:tc>
                <a:extLst>
                  <a:ext uri="{0D108BD9-81ED-4DB2-BD59-A6C34878D82A}">
                    <a16:rowId xmlns:a16="http://schemas.microsoft.com/office/drawing/2014/main" val="2574560813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E00B4A09-1BB2-C848-ADB8-320A857027A2}"/>
              </a:ext>
            </a:extLst>
          </p:cNvPr>
          <p:cNvSpPr txBox="1"/>
          <p:nvPr/>
        </p:nvSpPr>
        <p:spPr>
          <a:xfrm>
            <a:off x="0" y="-47865"/>
            <a:ext cx="9144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tabLst>
                <a:tab pos="810260" algn="l"/>
              </a:tabLst>
            </a:pPr>
            <a:r>
              <a:rPr lang="en-GB" sz="900" dirty="0">
                <a:solidFill>
                  <a:srgbClr val="000000"/>
                </a:solidFill>
                <a:ea typeface="Times New Roman" panose="02020603050405020304" pitchFamily="18" charset="0"/>
              </a:rPr>
              <a:t>Bianchi, F. (2021). </a:t>
            </a:r>
            <a:r>
              <a:rPr lang="en-GB" sz="9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Replacing meat with alternative plant-based products (RE-MAP): A randomized controlled trial of a multicomponent </a:t>
            </a:r>
            <a:r>
              <a:rPr lang="en-GB" sz="9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behavioral</a:t>
            </a:r>
            <a:r>
              <a:rPr lang="en-GB" sz="9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intervention to reduce meat </a:t>
            </a:r>
            <a:r>
              <a:rPr lang="en-GB" sz="900" dirty="0">
                <a:solidFill>
                  <a:srgbClr val="000000"/>
                </a:solidFill>
                <a:ea typeface="Times New Roman" panose="02020603050405020304" pitchFamily="18" charset="0"/>
              </a:rPr>
              <a:t>consumption. </a:t>
            </a:r>
            <a:br>
              <a:rPr lang="en-GB" sz="900" dirty="0">
                <a:solidFill>
                  <a:srgbClr val="000000"/>
                </a:solidFill>
                <a:ea typeface="Times New Roman" panose="02020603050405020304" pitchFamily="18" charset="0"/>
              </a:rPr>
            </a:br>
            <a:r>
              <a:rPr lang="en-GB" sz="900" dirty="0">
                <a:solidFill>
                  <a:srgbClr val="000000"/>
                </a:solidFill>
                <a:ea typeface="Times New Roman" panose="02020603050405020304" pitchFamily="18" charset="0"/>
              </a:rPr>
              <a:t>On-line supplementary material.</a:t>
            </a:r>
            <a:endParaRPr lang="en-GB" sz="900" dirty="0">
              <a:effectLst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4868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666</Words>
  <Application>Microsoft Macintosh PowerPoint</Application>
  <PresentationFormat>On-screen Show (4:3)</PresentationFormat>
  <Paragraphs>4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ian Cook</dc:creator>
  <cp:lastModifiedBy>Brian Cook</cp:lastModifiedBy>
  <cp:revision>2</cp:revision>
  <dcterms:created xsi:type="dcterms:W3CDTF">2021-10-28T06:38:36Z</dcterms:created>
  <dcterms:modified xsi:type="dcterms:W3CDTF">2021-12-06T15:48:31Z</dcterms:modified>
</cp:coreProperties>
</file>